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936C2-17C8-4195-B48E-027F835E41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488F8-1E07-4DCD-88B9-1C04C15C1A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87898-A35B-41E1-AC1C-88B6CEE6BF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8C36A-2846-438D-93A4-9881F1D901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5B18E-AD9B-4857-8DBA-FDE294D5BB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34697-FA81-4238-8057-C445F239E4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96B5C-F3E3-49D4-A2FB-1FCBFA2CB7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104C6-FC60-4628-9AC0-F622D7C7C2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C929A-A516-4D09-AF66-4AAC90D363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8068E-E7FF-4669-8898-A19A96B07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4196A-372C-4A7D-BDC8-1DD3116817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13630-3EC2-46C7-9EA1-39B51ED5D6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4EB8E7-F3AE-44BF-A5D3-42239ADE126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688320" y="4365720"/>
            <a:ext cx="4604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upplementary Tabl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nteractions between Dyskerin expression and known prognosis facto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826920" y="692280"/>
          <a:ext cx="7212240" cy="2842920"/>
        </p:xfrm>
        <a:graphic>
          <a:graphicData uri="http://schemas.openxmlformats.org/drawingml/2006/table">
            <a:tbl>
              <a:tblPr/>
              <a:tblGrid>
                <a:gridCol w="1009800"/>
                <a:gridCol w="738360"/>
                <a:gridCol w="496800"/>
                <a:gridCol w="496800"/>
                <a:gridCol w="496800"/>
                <a:gridCol w="497160"/>
                <a:gridCol w="496800"/>
                <a:gridCol w="495360"/>
                <a:gridCol w="496800"/>
                <a:gridCol w="496800"/>
                <a:gridCol w="496800"/>
                <a:gridCol w="497160"/>
                <a:gridCol w="496800"/>
              </a:tblGrid>
              <a:tr h="1591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FS cox p value p value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S cox p value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S after treatment cox p value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42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 Dyskerin expressio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rrelation with  Dyskerin (student's ttest p value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 factor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di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 factor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di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 factor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di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active with Dysker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x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n (n=67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oman (n=3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7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e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65 (n=52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9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65 (n=52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mmunoglobul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tated (n=58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mutated (n=44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76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CDT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 (n=63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gh (n=18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q deletio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bsent (n=76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sent (n=18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q deletio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bsent (n=36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0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7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sent (n=58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p deletio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bsent (n=9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sent (n=5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5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isomy 1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bsent (n=84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3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1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4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9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6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2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sent n=10)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8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3400"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30% (n=66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480" rIns="648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30% (n=28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480" marR="64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4T16:57:58Z</dcterms:created>
  <dc:creator>Emilie Horvilleur</dc:creator>
  <dc:description/>
  <dc:language>en-US</dc:language>
  <cp:lastModifiedBy>kc.lalitha</cp:lastModifiedBy>
  <dcterms:modified xsi:type="dcterms:W3CDTF">2016-05-30T08:27:28Z</dcterms:modified>
  <cp:revision>4</cp:revision>
  <dc:subject/>
  <dc:title>PowerPoint Presentation</dc:title>
</cp:coreProperties>
</file>